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  <p:sldId id="261" r:id="rId4"/>
    <p:sldId id="262" r:id="rId5"/>
  </p:sldIdLst>
  <p:sldSz cx="12192000" cy="6858000"/>
  <p:notesSz cx="6858000" cy="9144000"/>
  <p:custDataLst>
    <p:tags r:id="rId6"/>
  </p:custDataLst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B6F9928-8FA0-470E-874A-6EE30B657ADE}" v="8" dt="2024-07-28T18:49:16.41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6" d="100"/>
          <a:sy n="86" d="100"/>
        </p:scale>
        <p:origin x="562" y="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gs" Target="tags/tag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enata Carla Chelariu" userId="aa435bb0-a62e-4905-9920-64b2891fab3f" providerId="ADAL" clId="{0B6F9928-8FA0-470E-874A-6EE30B657ADE}"/>
    <pc:docChg chg="custSel addSld delSld modSld">
      <pc:chgData name="Renata Carla Chelariu" userId="aa435bb0-a62e-4905-9920-64b2891fab3f" providerId="ADAL" clId="{0B6F9928-8FA0-470E-874A-6EE30B657ADE}" dt="2024-07-28T19:01:12.952" v="106" actId="2696"/>
      <pc:docMkLst>
        <pc:docMk/>
      </pc:docMkLst>
      <pc:sldChg chg="modSp del mod">
        <pc:chgData name="Renata Carla Chelariu" userId="aa435bb0-a62e-4905-9920-64b2891fab3f" providerId="ADAL" clId="{0B6F9928-8FA0-470E-874A-6EE30B657ADE}" dt="2024-07-28T19:01:12.952" v="106" actId="2696"/>
        <pc:sldMkLst>
          <pc:docMk/>
          <pc:sldMk cId="0" sldId="260"/>
        </pc:sldMkLst>
        <pc:spChg chg="mod">
          <ac:chgData name="Renata Carla Chelariu" userId="aa435bb0-a62e-4905-9920-64b2891fab3f" providerId="ADAL" clId="{0B6F9928-8FA0-470E-874A-6EE30B657ADE}" dt="2024-07-28T18:51:23.093" v="101" actId="20577"/>
          <ac:spMkLst>
            <pc:docMk/>
            <pc:sldMk cId="0" sldId="260"/>
            <ac:spMk id="4" creationId="{00000000-0000-0000-0000-000000000000}"/>
          </ac:spMkLst>
        </pc:spChg>
      </pc:sldChg>
      <pc:sldChg chg="addSp delSp modSp new mod">
        <pc:chgData name="Renata Carla Chelariu" userId="aa435bb0-a62e-4905-9920-64b2891fab3f" providerId="ADAL" clId="{0B6F9928-8FA0-470E-874A-6EE30B657ADE}" dt="2024-07-28T18:56:13.371" v="105" actId="255"/>
        <pc:sldMkLst>
          <pc:docMk/>
          <pc:sldMk cId="4145285407" sldId="262"/>
        </pc:sldMkLst>
        <pc:spChg chg="del">
          <ac:chgData name="Renata Carla Chelariu" userId="aa435bb0-a62e-4905-9920-64b2891fab3f" providerId="ADAL" clId="{0B6F9928-8FA0-470E-874A-6EE30B657ADE}" dt="2024-07-28T18:43:57.109" v="1" actId="21"/>
          <ac:spMkLst>
            <pc:docMk/>
            <pc:sldMk cId="4145285407" sldId="262"/>
            <ac:spMk id="2" creationId="{4BFC1502-35DA-4773-81D0-2F44757CFF1E}"/>
          </ac:spMkLst>
        </pc:spChg>
        <pc:spChg chg="del mod">
          <ac:chgData name="Renata Carla Chelariu" userId="aa435bb0-a62e-4905-9920-64b2891fab3f" providerId="ADAL" clId="{0B6F9928-8FA0-470E-874A-6EE30B657ADE}" dt="2024-07-28T18:44:01.933" v="3"/>
          <ac:spMkLst>
            <pc:docMk/>
            <pc:sldMk cId="4145285407" sldId="262"/>
            <ac:spMk id="3" creationId="{71AB6C67-E2DF-4B34-8324-0039AD8F58C6}"/>
          </ac:spMkLst>
        </pc:spChg>
        <pc:spChg chg="add del mod">
          <ac:chgData name="Renata Carla Chelariu" userId="aa435bb0-a62e-4905-9920-64b2891fab3f" providerId="ADAL" clId="{0B6F9928-8FA0-470E-874A-6EE30B657ADE}" dt="2024-07-28T18:44:04.718" v="4"/>
          <ac:spMkLst>
            <pc:docMk/>
            <pc:sldMk cId="4145285407" sldId="262"/>
            <ac:spMk id="4" creationId="{AE80B1DB-9673-4971-8213-9B49F9A4ABEA}"/>
          </ac:spMkLst>
        </pc:spChg>
        <pc:spChg chg="add mod">
          <ac:chgData name="Renata Carla Chelariu" userId="aa435bb0-a62e-4905-9920-64b2891fab3f" providerId="ADAL" clId="{0B6F9928-8FA0-470E-874A-6EE30B657ADE}" dt="2024-07-28T18:56:13.371" v="105" actId="255"/>
          <ac:spMkLst>
            <pc:docMk/>
            <pc:sldMk cId="4145285407" sldId="262"/>
            <ac:spMk id="5" creationId="{D980ADD1-E1E1-4680-8E13-E5D62344DA89}"/>
          </ac:spMkLst>
        </pc:spChg>
        <pc:graphicFrameChg chg="add del mod">
          <ac:chgData name="Renata Carla Chelariu" userId="aa435bb0-a62e-4905-9920-64b2891fab3f" providerId="ADAL" clId="{0B6F9928-8FA0-470E-874A-6EE30B657ADE}" dt="2024-07-28T18:45:03.398" v="8"/>
          <ac:graphicFrameMkLst>
            <pc:docMk/>
            <pc:sldMk cId="4145285407" sldId="262"/>
            <ac:graphicFrameMk id="6" creationId="{1AC0D8F0-8B19-416C-B84A-4B547E4BA71A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0EBCA-564B-464C-9B35-F56D1BDEAC49}" type="datetimeFigureOut">
              <a:rPr lang="zh-TW" altLang="en-US" smtClean="0"/>
              <a:t>2024/7/2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069C0-82B8-4E2F-AB2C-0458A8C76658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0EBCA-564B-464C-9B35-F56D1BDEAC49}" type="datetimeFigureOut">
              <a:rPr lang="zh-TW" altLang="en-US" smtClean="0"/>
              <a:t>2024/7/2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069C0-82B8-4E2F-AB2C-0458A8C76658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0EBCA-564B-464C-9B35-F56D1BDEAC49}" type="datetimeFigureOut">
              <a:rPr lang="zh-TW" altLang="en-US" smtClean="0"/>
              <a:t>2024/7/2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069C0-82B8-4E2F-AB2C-0458A8C76658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0EBCA-564B-464C-9B35-F56D1BDEAC49}" type="datetimeFigureOut">
              <a:rPr lang="zh-TW" altLang="en-US" smtClean="0"/>
              <a:t>2024/7/2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069C0-82B8-4E2F-AB2C-0458A8C76658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 hasCustomPrompt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0EBCA-564B-464C-9B35-F56D1BDEAC49}" type="datetimeFigureOut">
              <a:rPr lang="zh-TW" altLang="en-US" smtClean="0"/>
              <a:t>2024/7/2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069C0-82B8-4E2F-AB2C-0458A8C76658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 hasCustomPrompt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 hasCustomPrompt="1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0EBCA-564B-464C-9B35-F56D1BDEAC49}" type="datetimeFigureOut">
              <a:rPr lang="zh-TW" altLang="en-US" smtClean="0"/>
              <a:t>2024/7/2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069C0-82B8-4E2F-AB2C-0458A8C76658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 hasCustomPrompt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 hasCustomPrompt="1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 hasCustomPrompt="1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0EBCA-564B-464C-9B35-F56D1BDEAC49}" type="datetimeFigureOut">
              <a:rPr lang="zh-TW" altLang="en-US" smtClean="0"/>
              <a:t>2024/7/28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069C0-82B8-4E2F-AB2C-0458A8C76658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0EBCA-564B-464C-9B35-F56D1BDEAC49}" type="datetimeFigureOut">
              <a:rPr lang="zh-TW" altLang="en-US" smtClean="0"/>
              <a:t>2024/7/28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069C0-82B8-4E2F-AB2C-0458A8C76658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0EBCA-564B-464C-9B35-F56D1BDEAC49}" type="datetimeFigureOut">
              <a:rPr lang="zh-TW" altLang="en-US" smtClean="0"/>
              <a:t>2024/7/28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069C0-82B8-4E2F-AB2C-0458A8C76658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 hasCustomPrompt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0EBCA-564B-464C-9B35-F56D1BDEAC49}" type="datetimeFigureOut">
              <a:rPr lang="zh-TW" altLang="en-US" smtClean="0"/>
              <a:t>2024/7/2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069C0-82B8-4E2F-AB2C-0458A8C76658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0EBCA-564B-464C-9B35-F56D1BDEAC49}" type="datetimeFigureOut">
              <a:rPr lang="zh-TW" altLang="en-US" smtClean="0"/>
              <a:t>2024/7/2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069C0-82B8-4E2F-AB2C-0458A8C76658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50EBCA-564B-464C-9B35-F56D1BDEAC49}" type="datetimeFigureOut">
              <a:rPr lang="zh-TW" altLang="en-US" smtClean="0"/>
              <a:t>2024/7/2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F069C0-82B8-4E2F-AB2C-0458A8C76658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hyperlink" Target="https://doi.org/10.16241/j.cnki.1001-5914.2006.01.028" TargetMode="External"/><Relationship Id="rId2" Type="http://schemas.openxmlformats.org/officeDocument/2006/relationships/hyperlink" Target="https://doi.org/10.1016/j.jep.2016.03.044" TargetMode="Externa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doi.org/10.1080/14786419.2017.1332612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464456" y="411036"/>
          <a:ext cx="11451773" cy="645506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33531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7250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51899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67022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5474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475675">
                <a:tc>
                  <a:txBody>
                    <a:bodyPr/>
                    <a:lstStyle/>
                    <a:p>
                      <a:pPr indent="127635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Species</a:t>
                      </a:r>
                      <a:endParaRPr lang="zh-TW" sz="11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</a:rPr>
                        <a:t>Characterization</a:t>
                      </a:r>
                      <a:endParaRPr lang="zh-TW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25527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Active components</a:t>
                      </a:r>
                      <a:endParaRPr lang="zh-TW" sz="11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25527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</a:rPr>
                        <a:t>Biological activity</a:t>
                      </a:r>
                      <a:endParaRPr lang="zh-TW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</a:rPr>
                        <a:t>References</a:t>
                      </a:r>
                      <a:endParaRPr lang="zh-TW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687211"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 err="1">
                          <a:effectLst/>
                        </a:rPr>
                        <a:t>Fokienia</a:t>
                      </a:r>
                      <a:r>
                        <a:rPr lang="en-US" sz="1000" kern="0" dirty="0">
                          <a:effectLst/>
                        </a:rPr>
                        <a:t> </a:t>
                      </a:r>
                      <a:endParaRPr lang="zh-TW" sz="1100" kern="100" dirty="0">
                        <a:effectLst/>
                      </a:endParaRPr>
                    </a:p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 err="1">
                          <a:effectLst/>
                        </a:rPr>
                        <a:t>hodginsii</a:t>
                      </a:r>
                      <a:r>
                        <a:rPr lang="en-US" sz="1000" kern="0" dirty="0">
                          <a:effectLst/>
                        </a:rPr>
                        <a:t>.</a:t>
                      </a:r>
                      <a:endParaRPr lang="zh-TW" sz="11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254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</a:rPr>
                        <a:t> </a:t>
                      </a:r>
                      <a:endParaRPr lang="zh-TW" sz="1100" kern="100">
                        <a:effectLst/>
                      </a:endParaRPr>
                    </a:p>
                    <a:p>
                      <a:pPr indent="254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</a:rPr>
                        <a:t> </a:t>
                      </a:r>
                      <a:endParaRPr lang="zh-TW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</a:rPr>
                        <a:t>isopimarane diterpenoids, (fokihodgins A-E); labdane diterpenoids, (fokihodgins F-I); icetexane diterpenoid, fokihodgin J</a:t>
                      </a:r>
                      <a:endParaRPr lang="zh-TW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</a:rPr>
                        <a:t>HL-60 and SMMC-7721 cell lines, with IC</a:t>
                      </a:r>
                      <a:r>
                        <a:rPr lang="en-US" sz="1000" kern="0" baseline="-25000">
                          <a:effectLst/>
                        </a:rPr>
                        <a:t>50</a:t>
                      </a:r>
                      <a:r>
                        <a:rPr lang="en-US" sz="1000" kern="0">
                          <a:effectLst/>
                        </a:rPr>
                        <a:t> values of 9.10 and 7.50 μM.</a:t>
                      </a:r>
                      <a:endParaRPr lang="zh-TW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254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</a:rPr>
                        <a:t>27</a:t>
                      </a:r>
                      <a:endParaRPr lang="zh-TW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16282"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0" dirty="0" err="1">
                          <a:effectLst/>
                        </a:rPr>
                        <a:t>Fokienia</a:t>
                      </a:r>
                      <a:r>
                        <a:rPr lang="en-US" sz="1000" i="1" kern="0" dirty="0">
                          <a:effectLst/>
                        </a:rPr>
                        <a:t> </a:t>
                      </a:r>
                      <a:r>
                        <a:rPr lang="en-US" sz="1000" i="1" kern="0" dirty="0" err="1">
                          <a:effectLst/>
                        </a:rPr>
                        <a:t>hodginsii</a:t>
                      </a:r>
                      <a:endParaRPr lang="zh-TW" sz="1100" i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</a:rPr>
                        <a:t> Twigs and leaves</a:t>
                      </a:r>
                      <a:endParaRPr lang="zh-TW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</a:rPr>
                        <a:t>rare carotane-type sesquiterpenoid, forkienin A (1), new eudesmane-type </a:t>
                      </a:r>
                      <a:endParaRPr lang="zh-TW" sz="1100" kern="100">
                        <a:effectLst/>
                      </a:endParaRPr>
                    </a:p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</a:rPr>
                        <a:t>sesquiterpenoid, forkienin B (2), new natural eudesmane-type sesquiterpenoid, forkienin C</a:t>
                      </a:r>
                      <a:endParaRPr lang="zh-TW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Cytotoxicity against HL-60, SMMC-7721, A-549, MCF-7, and SW480 cell lines.</a:t>
                      </a:r>
                      <a:endParaRPr lang="zh-TW" sz="11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254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</a:rPr>
                        <a:t>28</a:t>
                      </a:r>
                      <a:endParaRPr lang="zh-TW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872059"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0" dirty="0" err="1">
                          <a:effectLst/>
                        </a:rPr>
                        <a:t>Fokienia</a:t>
                      </a:r>
                      <a:r>
                        <a:rPr lang="en-US" sz="1000" i="1" kern="0" dirty="0">
                          <a:effectLst/>
                        </a:rPr>
                        <a:t> </a:t>
                      </a:r>
                      <a:r>
                        <a:rPr lang="en-US" sz="1000" i="1" kern="0" dirty="0" err="1">
                          <a:effectLst/>
                        </a:rPr>
                        <a:t>hodginsii</a:t>
                      </a:r>
                      <a:endParaRPr lang="zh-TW" sz="1100" i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0541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</a:rPr>
                        <a:t>leaves</a:t>
                      </a:r>
                      <a:endParaRPr lang="zh-TW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</a:rPr>
                        <a:t>diterpenoids, trans-communic acid (1), 13-oxo-15,16-dinor-labda-8(17), 11E-diene-19-oic acid (2), 3β-hydroxytotarol (3), and totarolone (4)  </a:t>
                      </a:r>
                      <a:endParaRPr lang="zh-TW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Antiproliferative activity in acute myeloid leukemia (OCI-AML) cells</a:t>
                      </a:r>
                      <a:endParaRPr lang="zh-TW" sz="11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254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</a:rPr>
                        <a:t>17</a:t>
                      </a:r>
                      <a:endParaRPr lang="zh-TW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26103"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0" dirty="0" err="1">
                          <a:effectLst/>
                        </a:rPr>
                        <a:t>Fokienia</a:t>
                      </a:r>
                      <a:r>
                        <a:rPr lang="en-US" sz="1000" i="1" kern="0" dirty="0">
                          <a:effectLst/>
                        </a:rPr>
                        <a:t> </a:t>
                      </a:r>
                      <a:r>
                        <a:rPr lang="en-US" sz="1000" i="1" kern="0" dirty="0" err="1">
                          <a:effectLst/>
                        </a:rPr>
                        <a:t>hodginsii</a:t>
                      </a:r>
                      <a:endParaRPr lang="zh-TW" sz="1100" i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254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 </a:t>
                      </a:r>
                      <a:endParaRPr lang="zh-TW" sz="11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</a:rPr>
                        <a:t>α"Pinene; 1"Octen"3"ol; D"Limonene; α"Terpineol; β"Elemen; Caryophyllene; α"Caryophyllene; β"Cubebene; γ"Cadinene; β"Cadinene; Caryophyllene oxide; τ"Cadinol; α"Cadinol; 7R,8R"8"Hydroxy"4"isopropylidene"7"methylbicyclol</a:t>
                      </a:r>
                      <a:endParaRPr lang="zh-TW" sz="11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Qi analgesic; Descending retching </a:t>
                      </a:r>
                      <a:endParaRPr lang="zh-TW" sz="1100" kern="100" dirty="0">
                        <a:effectLst/>
                      </a:endParaRPr>
                    </a:p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Epigastric pain, qi vomiting, rheumatoid arthritis, cold headache, abdominal pain. Qi to relieve pain and reduce retinitis</a:t>
                      </a:r>
                      <a:endParaRPr lang="zh-TW" sz="11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254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26,30</a:t>
                      </a:r>
                      <a:endParaRPr lang="zh-TW" sz="11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80205"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 err="1">
                          <a:effectLst/>
                        </a:rPr>
                        <a:t>Sonchus</a:t>
                      </a:r>
                      <a:r>
                        <a:rPr lang="en-US" sz="1000" kern="0" dirty="0">
                          <a:effectLst/>
                        </a:rPr>
                        <a:t> </a:t>
                      </a:r>
                    </a:p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 err="1">
                          <a:effectLst/>
                        </a:rPr>
                        <a:t>oleraceus</a:t>
                      </a:r>
                      <a:r>
                        <a:rPr lang="en-US" sz="1000" kern="0" dirty="0">
                          <a:effectLst/>
                        </a:rPr>
                        <a:t> (L.) L and J. </a:t>
                      </a:r>
                      <a:r>
                        <a:rPr lang="en-US" sz="1000" kern="0" dirty="0" err="1">
                          <a:effectLst/>
                        </a:rPr>
                        <a:t>sabina</a:t>
                      </a:r>
                      <a:r>
                        <a:rPr lang="en-US" sz="1000" kern="0" dirty="0">
                          <a:effectLst/>
                        </a:rPr>
                        <a:t> L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 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 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Anti-tumor effects via up-regulation of the apoptosis-related genes </a:t>
                      </a:r>
                      <a:r>
                        <a:rPr lang="en-US" sz="1000" kern="0" dirty="0" err="1">
                          <a:effectLst/>
                        </a:rPr>
                        <a:t>FasL</a:t>
                      </a:r>
                      <a:r>
                        <a:rPr lang="en-US" sz="1000" kern="0" dirty="0">
                          <a:effectLst/>
                        </a:rPr>
                        <a:t>, caspase 3 and caspase 9; inhibited expression of ICAM-1, MMP-2 and MMP-9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16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697531"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 err="1">
                          <a:effectLst/>
                        </a:rPr>
                        <a:t>Juniperus</a:t>
                      </a:r>
                      <a:r>
                        <a:rPr lang="en-US" sz="1000" kern="0" dirty="0">
                          <a:effectLst/>
                        </a:rPr>
                        <a:t> </a:t>
                      </a:r>
                      <a:r>
                        <a:rPr lang="en-US" sz="1000" kern="0" dirty="0" err="1">
                          <a:effectLst/>
                        </a:rPr>
                        <a:t>sabina</a:t>
                      </a:r>
                      <a:r>
                        <a:rPr lang="en-US" sz="1000" kern="0" dirty="0">
                          <a:effectLst/>
                        </a:rPr>
                        <a:t> L.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 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Essential oil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 err="1">
                          <a:effectLst/>
                        </a:rPr>
                        <a:t>Hepatoprotective</a:t>
                      </a:r>
                      <a:r>
                        <a:rPr lang="en-US" sz="1000" kern="0" dirty="0">
                          <a:effectLst/>
                        </a:rPr>
                        <a:t> activity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17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2646976" y="134037"/>
            <a:ext cx="6467527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spAutoFit/>
          </a:bodyPr>
          <a:lstStyle>
            <a:lvl1pPr indent="254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1270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Palatino Linotype" panose="02040502050505030304" pitchFamily="18" charset="0"/>
              </a:rPr>
              <a:t>Table S1. The chemo-information and biological functions of </a:t>
            </a:r>
            <a:r>
              <a:rPr kumimoji="0" lang="en-US" altLang="zh-CN" sz="12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Palatino Linotype" panose="02040502050505030304" pitchFamily="18" charset="0"/>
              </a:rPr>
              <a:t>Cupressaceae</a:t>
            </a:r>
            <a:r>
              <a:rPr kumimoji="0" lang="en-US" altLang="zh-CN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Palatino Linotype" panose="02040502050505030304" pitchFamily="18" charset="0"/>
              </a:rPr>
              <a:t> species.</a:t>
            </a:r>
            <a:endParaRPr kumimoji="0" lang="en-US" altLang="zh-TW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1270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endParaRPr kumimoji="0" lang="en-US" altLang="zh-TW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783772" y="475234"/>
          <a:ext cx="10972800" cy="6114251"/>
        </p:xfrm>
        <a:graphic>
          <a:graphicData uri="http://schemas.openxmlformats.org/drawingml/2006/table">
            <a:tbl>
              <a:tblPr firstCol="1" bandRow="1">
                <a:tableStyleId>{5C22544A-7EE6-4342-B048-85BDC9FD1C3A}</a:tableStyleId>
              </a:tblPr>
              <a:tblGrid>
                <a:gridCol w="166468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3292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851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04484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4182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723372"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0" dirty="0" err="1">
                          <a:effectLst/>
                        </a:rPr>
                        <a:t>Juniperus</a:t>
                      </a:r>
                      <a:r>
                        <a:rPr lang="en-US" sz="1000" i="1" kern="0" dirty="0">
                          <a:effectLst/>
                        </a:rPr>
                        <a:t> </a:t>
                      </a:r>
                      <a:r>
                        <a:rPr lang="en-US" sz="1000" i="1" kern="0" dirty="0" err="1">
                          <a:effectLst/>
                        </a:rPr>
                        <a:t>sabina</a:t>
                      </a:r>
                      <a:r>
                        <a:rPr lang="en-US" sz="1000" i="1" kern="0" dirty="0">
                          <a:effectLst/>
                        </a:rPr>
                        <a:t> </a:t>
                      </a:r>
                      <a:r>
                        <a:rPr lang="en-US" sz="1000" kern="0" dirty="0">
                          <a:effectLst/>
                        </a:rPr>
                        <a:t>L.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needle extract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podophyllotoxin and </a:t>
                      </a:r>
                      <a:r>
                        <a:rPr lang="en-US" sz="1000" kern="0" dirty="0" err="1">
                          <a:effectLst/>
                        </a:rPr>
                        <a:t>deoxypodophyllotoxin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anti-</a:t>
                      </a:r>
                      <a:r>
                        <a:rPr lang="en-US" sz="1000" kern="0" dirty="0" err="1">
                          <a:effectLst/>
                        </a:rPr>
                        <a:t>butyrylcholinesterase</a:t>
                      </a:r>
                      <a:r>
                        <a:rPr lang="en-US" sz="1000" kern="0" dirty="0">
                          <a:effectLst/>
                        </a:rPr>
                        <a:t> activity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18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69143"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0" dirty="0" err="1">
                          <a:effectLst/>
                        </a:rPr>
                        <a:t>Juniperus</a:t>
                      </a:r>
                      <a:r>
                        <a:rPr lang="en-US" sz="1000" i="1" kern="0" dirty="0">
                          <a:effectLst/>
                        </a:rPr>
                        <a:t> </a:t>
                      </a:r>
                      <a:r>
                        <a:rPr lang="en-US" sz="1000" i="1" kern="0" dirty="0" err="1">
                          <a:effectLst/>
                        </a:rPr>
                        <a:t>sabina</a:t>
                      </a:r>
                      <a:r>
                        <a:rPr lang="en-US" sz="1000" i="1" kern="0" dirty="0">
                          <a:effectLst/>
                        </a:rPr>
                        <a:t> </a:t>
                      </a:r>
                      <a:r>
                        <a:rPr lang="en-US" sz="1000" kern="0" dirty="0">
                          <a:effectLst/>
                        </a:rPr>
                        <a:t>L.</a:t>
                      </a:r>
                      <a:endParaRPr lang="zh-TW" sz="1200" kern="100" dirty="0">
                        <a:effectLst/>
                      </a:endParaRPr>
                    </a:p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 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aerial parts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 err="1">
                          <a:effectLst/>
                        </a:rPr>
                        <a:t>Sesquiterpenes</a:t>
                      </a:r>
                      <a:r>
                        <a:rPr lang="en-US" sz="1000" kern="0" dirty="0">
                          <a:effectLst/>
                        </a:rPr>
                        <a:t>, </a:t>
                      </a:r>
                      <a:r>
                        <a:rPr lang="en-US" sz="1000" kern="0" dirty="0" err="1">
                          <a:effectLst/>
                        </a:rPr>
                        <a:t>diterpenes</a:t>
                      </a:r>
                      <a:r>
                        <a:rPr lang="en-US" sz="1000" kern="0" dirty="0">
                          <a:effectLst/>
                        </a:rPr>
                        <a:t> trans-</a:t>
                      </a:r>
                      <a:r>
                        <a:rPr lang="en-US" sz="1000" kern="0" dirty="0" err="1">
                          <a:effectLst/>
                        </a:rPr>
                        <a:t>calamenene</a:t>
                      </a:r>
                      <a:r>
                        <a:rPr lang="en-US" sz="1000" kern="0" dirty="0">
                          <a:effectLst/>
                        </a:rPr>
                        <a:t> (1), </a:t>
                      </a:r>
                      <a:r>
                        <a:rPr lang="en-US" sz="1000" kern="0" dirty="0" err="1">
                          <a:effectLst/>
                        </a:rPr>
                        <a:t>cadalene</a:t>
                      </a:r>
                      <a:r>
                        <a:rPr lang="en-US" sz="1000" kern="0" dirty="0">
                          <a:effectLst/>
                        </a:rPr>
                        <a:t> (</a:t>
                      </a:r>
                      <a:r>
                        <a:rPr lang="en-US" sz="1000" kern="0" dirty="0" err="1">
                          <a:effectLst/>
                        </a:rPr>
                        <a:t>cadalin</a:t>
                      </a:r>
                      <a:r>
                        <a:rPr lang="en-US" sz="1000" kern="0" dirty="0">
                          <a:effectLst/>
                        </a:rPr>
                        <a:t>) (2), epi-</a:t>
                      </a:r>
                      <a:r>
                        <a:rPr lang="en-US" sz="1000" kern="0" dirty="0" err="1">
                          <a:effectLst/>
                        </a:rPr>
                        <a:t>cubenol</a:t>
                      </a:r>
                      <a:r>
                        <a:rPr lang="en-US" sz="1000" kern="0" dirty="0">
                          <a:effectLst/>
                        </a:rPr>
                        <a:t> (3), </a:t>
                      </a:r>
                      <a:r>
                        <a:rPr lang="en-US" sz="1000" kern="0" dirty="0" err="1">
                          <a:effectLst/>
                        </a:rPr>
                        <a:t>manool</a:t>
                      </a:r>
                      <a:r>
                        <a:rPr lang="en-US" sz="1000" kern="0" dirty="0">
                          <a:effectLst/>
                        </a:rPr>
                        <a:t> (4), calamenene-10β-</a:t>
                      </a:r>
                      <a:r>
                        <a:rPr lang="en-US" sz="1000" kern="0" dirty="0" err="1">
                          <a:effectLst/>
                        </a:rPr>
                        <a:t>ol</a:t>
                      </a:r>
                      <a:r>
                        <a:rPr lang="en-US" sz="1000" kern="0" dirty="0">
                          <a:effectLst/>
                        </a:rPr>
                        <a:t> (5), calamenene-10α-</a:t>
                      </a:r>
                      <a:r>
                        <a:rPr lang="en-US" sz="1000" kern="0" dirty="0" err="1">
                          <a:effectLst/>
                        </a:rPr>
                        <a:t>ol</a:t>
                      </a:r>
                      <a:r>
                        <a:rPr lang="en-US" sz="1000" kern="0" dirty="0">
                          <a:effectLst/>
                        </a:rPr>
                        <a:t> (6), 4-epi-abietic acid (7), </a:t>
                      </a:r>
                      <a:r>
                        <a:rPr lang="en-US" sz="1000" kern="0" dirty="0" err="1">
                          <a:effectLst/>
                        </a:rPr>
                        <a:t>sandaracopimaric</a:t>
                      </a:r>
                      <a:r>
                        <a:rPr lang="en-US" sz="1000" kern="0" dirty="0">
                          <a:effectLst/>
                        </a:rPr>
                        <a:t> acid (8), </a:t>
                      </a:r>
                      <a:r>
                        <a:rPr lang="en-US" sz="1000" kern="0" dirty="0" err="1">
                          <a:effectLst/>
                        </a:rPr>
                        <a:t>bisopimaric</a:t>
                      </a:r>
                      <a:r>
                        <a:rPr lang="en-US" sz="1000" kern="0" dirty="0">
                          <a:effectLst/>
                        </a:rPr>
                        <a:t> acid (9). Compounds 1-3, 5 and 6 are belonging to </a:t>
                      </a:r>
                      <a:r>
                        <a:rPr lang="en-US" sz="1000" kern="0" dirty="0" err="1">
                          <a:effectLst/>
                        </a:rPr>
                        <a:t>cadinane</a:t>
                      </a:r>
                      <a:r>
                        <a:rPr lang="en-US" sz="1000" kern="0" dirty="0">
                          <a:effectLst/>
                        </a:rPr>
                        <a:t> </a:t>
                      </a:r>
                      <a:r>
                        <a:rPr lang="en-US" sz="1000" kern="0" dirty="0" err="1">
                          <a:effectLst/>
                        </a:rPr>
                        <a:t>sesquiterepenes</a:t>
                      </a:r>
                      <a:r>
                        <a:rPr lang="en-US" sz="1000" kern="0" dirty="0">
                          <a:effectLst/>
                        </a:rPr>
                        <a:t>, while compounds 4, 7-9 were of </a:t>
                      </a:r>
                      <a:r>
                        <a:rPr lang="en-US" sz="1000" kern="0" dirty="0" err="1">
                          <a:effectLst/>
                        </a:rPr>
                        <a:t>diterpene</a:t>
                      </a:r>
                      <a:r>
                        <a:rPr lang="en-US" sz="1000" kern="0" dirty="0">
                          <a:effectLst/>
                        </a:rPr>
                        <a:t> skeleton.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Hepatoprotective effect.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17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132114"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0" dirty="0" err="1">
                          <a:effectLst/>
                        </a:rPr>
                        <a:t>Juniperus</a:t>
                      </a:r>
                      <a:r>
                        <a:rPr lang="en-US" sz="1000" i="1" kern="0" dirty="0">
                          <a:effectLst/>
                        </a:rPr>
                        <a:t> </a:t>
                      </a:r>
                      <a:r>
                        <a:rPr lang="en-US" sz="1000" i="1" kern="0" dirty="0" err="1">
                          <a:effectLst/>
                        </a:rPr>
                        <a:t>sabina</a:t>
                      </a:r>
                      <a:endParaRPr lang="zh-TW" sz="1200" i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254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 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 err="1">
                          <a:effectLst/>
                        </a:rPr>
                        <a:t>Catechin</a:t>
                      </a:r>
                      <a:r>
                        <a:rPr lang="en-US" sz="1000" kern="0" dirty="0">
                          <a:effectLst/>
                        </a:rPr>
                        <a:t>, </a:t>
                      </a:r>
                      <a:r>
                        <a:rPr lang="en-US" sz="1000" kern="0" dirty="0" err="1">
                          <a:effectLst/>
                        </a:rPr>
                        <a:t>quercitrin</a:t>
                      </a:r>
                      <a:r>
                        <a:rPr lang="en-US" sz="1000" kern="0" dirty="0">
                          <a:effectLst/>
                        </a:rPr>
                        <a:t>, </a:t>
                      </a:r>
                      <a:r>
                        <a:rPr lang="en-US" sz="1000" kern="0" dirty="0" err="1">
                          <a:effectLst/>
                        </a:rPr>
                        <a:t>isoquercitrin</a:t>
                      </a:r>
                      <a:r>
                        <a:rPr lang="en-US" sz="1000" kern="0" dirty="0">
                          <a:effectLst/>
                        </a:rPr>
                        <a:t>, </a:t>
                      </a:r>
                      <a:r>
                        <a:rPr lang="en-US" sz="1000" kern="0" dirty="0" err="1">
                          <a:effectLst/>
                        </a:rPr>
                        <a:t>isoscutellarein</a:t>
                      </a:r>
                      <a:r>
                        <a:rPr lang="en-US" sz="1000" kern="0" dirty="0">
                          <a:effectLst/>
                        </a:rPr>
                        <a:t> 7-O-β-D-</a:t>
                      </a:r>
                      <a:r>
                        <a:rPr lang="en-US" sz="1000" kern="0" dirty="0" err="1">
                          <a:effectLst/>
                        </a:rPr>
                        <a:t>xylopyranoside</a:t>
                      </a:r>
                      <a:r>
                        <a:rPr lang="en-US" sz="1000" kern="0" dirty="0">
                          <a:effectLst/>
                        </a:rPr>
                        <a:t>, </a:t>
                      </a:r>
                      <a:r>
                        <a:rPr lang="en-US" sz="1000" kern="0" dirty="0" err="1">
                          <a:effectLst/>
                        </a:rPr>
                        <a:t>isoscutellarein</a:t>
                      </a:r>
                      <a:r>
                        <a:rPr lang="en-US" sz="1000" kern="0" dirty="0">
                          <a:effectLst/>
                        </a:rPr>
                        <a:t> 7-O-β-D-</a:t>
                      </a:r>
                      <a:r>
                        <a:rPr lang="en-US" sz="1000" kern="0" dirty="0" err="1">
                          <a:effectLst/>
                        </a:rPr>
                        <a:t>xylopyranose</a:t>
                      </a:r>
                      <a:r>
                        <a:rPr lang="en-US" sz="1000" kern="0" dirty="0">
                          <a:effectLst/>
                        </a:rPr>
                        <a:t>-(1 →3)-α-L-</a:t>
                      </a:r>
                      <a:r>
                        <a:rPr lang="en-US" sz="1000" kern="0" dirty="0" err="1">
                          <a:effectLst/>
                        </a:rPr>
                        <a:t>rhamnoside</a:t>
                      </a:r>
                      <a:r>
                        <a:rPr lang="en-US" sz="1000" kern="0" dirty="0">
                          <a:effectLst/>
                        </a:rPr>
                        <a:t>, and </a:t>
                      </a:r>
                      <a:r>
                        <a:rPr lang="en-US" sz="1000" kern="0" dirty="0" err="1">
                          <a:effectLst/>
                        </a:rPr>
                        <a:t>rutin</a:t>
                      </a:r>
                      <a:r>
                        <a:rPr lang="en-US" sz="1000" kern="0" dirty="0">
                          <a:effectLst/>
                        </a:rPr>
                        <a:t>.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RA-induced by Complete Freund's Adjuvant (CFA) in rats.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254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76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09486"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0" dirty="0" err="1">
                          <a:effectLst/>
                        </a:rPr>
                        <a:t>Juniperus</a:t>
                      </a:r>
                      <a:r>
                        <a:rPr lang="en-US" sz="1000" i="1" kern="0" dirty="0">
                          <a:effectLst/>
                        </a:rPr>
                        <a:t> </a:t>
                      </a:r>
                      <a:r>
                        <a:rPr lang="en-US" sz="1000" i="1" kern="0" dirty="0" err="1">
                          <a:effectLst/>
                        </a:rPr>
                        <a:t>foetidissima</a:t>
                      </a:r>
                      <a:r>
                        <a:rPr lang="en-US" sz="1000" i="1" kern="0" dirty="0">
                          <a:effectLst/>
                        </a:rPr>
                        <a:t> </a:t>
                      </a:r>
                      <a:r>
                        <a:rPr lang="en-US" sz="1000" i="1" kern="0" dirty="0" err="1">
                          <a:effectLst/>
                        </a:rPr>
                        <a:t>Willd</a:t>
                      </a:r>
                      <a:r>
                        <a:rPr lang="en-US" sz="1000" i="1" kern="0" dirty="0">
                          <a:effectLst/>
                        </a:rPr>
                        <a:t>. and J. </a:t>
                      </a:r>
                      <a:r>
                        <a:rPr lang="en-US" sz="1000" i="1" kern="0" dirty="0" err="1">
                          <a:effectLst/>
                        </a:rPr>
                        <a:t>sabina</a:t>
                      </a:r>
                      <a:r>
                        <a:rPr lang="en-US" sz="1000" i="1" kern="0" dirty="0">
                          <a:effectLst/>
                        </a:rPr>
                        <a:t> L.</a:t>
                      </a:r>
                      <a:endParaRPr lang="zh-TW" sz="1200" i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leaf and fruit extracts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</a:rPr>
                        <a:t>Amentoflavone</a:t>
                      </a:r>
                      <a:endParaRPr lang="zh-TW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</a:rPr>
                        <a:t>Antioxidant, In-vitro and In-vivo Antidiabetic Activities</a:t>
                      </a:r>
                      <a:endParaRPr lang="zh-TW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254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19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80136"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0" dirty="0">
                          <a:effectLst/>
                        </a:rPr>
                        <a:t>Sabina </a:t>
                      </a:r>
                      <a:r>
                        <a:rPr lang="en-US" sz="1000" i="1" kern="0" dirty="0" err="1">
                          <a:effectLst/>
                        </a:rPr>
                        <a:t>chinensis</a:t>
                      </a:r>
                      <a:r>
                        <a:rPr lang="en-US" sz="1000" i="1" kern="0" dirty="0">
                          <a:effectLst/>
                        </a:rPr>
                        <a:t> cv. </a:t>
                      </a:r>
                      <a:r>
                        <a:rPr lang="en-US" sz="1000" i="1" kern="0" dirty="0" err="1">
                          <a:effectLst/>
                        </a:rPr>
                        <a:t>Kaizuca</a:t>
                      </a:r>
                      <a:r>
                        <a:rPr lang="en-US" sz="1000" i="1" kern="0" dirty="0">
                          <a:effectLst/>
                        </a:rPr>
                        <a:t> (SCK) variant of S. </a:t>
                      </a:r>
                      <a:r>
                        <a:rPr lang="en-US" sz="1000" i="1" kern="0" dirty="0" err="1">
                          <a:effectLst/>
                        </a:rPr>
                        <a:t>chinensis</a:t>
                      </a:r>
                      <a:r>
                        <a:rPr lang="en-US" sz="1000" i="1" kern="0" dirty="0">
                          <a:effectLst/>
                        </a:rPr>
                        <a:t> L.</a:t>
                      </a:r>
                      <a:endParaRPr lang="zh-TW" sz="1200" i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254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 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 err="1">
                          <a:effectLst/>
                        </a:rPr>
                        <a:t>bornyl</a:t>
                      </a:r>
                      <a:r>
                        <a:rPr lang="en-US" sz="1000" kern="0" dirty="0">
                          <a:effectLst/>
                        </a:rPr>
                        <a:t> acetate (42.6%), </a:t>
                      </a:r>
                      <a:r>
                        <a:rPr lang="en-US" sz="1000" kern="0" dirty="0" err="1">
                          <a:effectLst/>
                        </a:rPr>
                        <a:t>elemol</a:t>
                      </a:r>
                      <a:r>
                        <a:rPr lang="en-US" sz="1000" kern="0" dirty="0">
                          <a:effectLst/>
                        </a:rPr>
                        <a:t> (20.5%), β-myrcene (13.7%), β-linalool (4.0%).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α-amylase inhibitory activity, γ-</a:t>
                      </a:r>
                      <a:r>
                        <a:rPr lang="en-US" sz="1000" kern="0" dirty="0" err="1">
                          <a:effectLst/>
                        </a:rPr>
                        <a:t>eudesmol</a:t>
                      </a:r>
                      <a:r>
                        <a:rPr lang="en-US" sz="1000" kern="0" dirty="0">
                          <a:effectLst/>
                        </a:rPr>
                        <a:t> exhibited the lowest binding energy (-6.73 kcal/mol), followed by α-copaen-11-ol (-6.66 kcal/mol), </a:t>
                      </a:r>
                      <a:r>
                        <a:rPr lang="en-US" sz="1000" kern="0" dirty="0" err="1">
                          <a:effectLst/>
                        </a:rPr>
                        <a:t>cubedol</a:t>
                      </a:r>
                      <a:r>
                        <a:rPr lang="en-US" sz="1000" kern="0" dirty="0">
                          <a:effectLst/>
                        </a:rPr>
                        <a:t> (-6.39 kcal/mol), α-</a:t>
                      </a:r>
                      <a:r>
                        <a:rPr lang="en-US" sz="1000" kern="0" dirty="0" err="1">
                          <a:effectLst/>
                        </a:rPr>
                        <a:t>acorenol</a:t>
                      </a:r>
                      <a:r>
                        <a:rPr lang="en-US" sz="1000" kern="0" dirty="0">
                          <a:effectLst/>
                        </a:rPr>
                        <a:t> (-6.12 kcal/mol).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254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33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537029" y="147485"/>
          <a:ext cx="11263086" cy="6292531"/>
        </p:xfrm>
        <a:graphic>
          <a:graphicData uri="http://schemas.openxmlformats.org/drawingml/2006/table">
            <a:tbl>
              <a:tblPr firstCol="1" bandRow="1">
                <a:tableStyleId>{5C22544A-7EE6-4342-B048-85BDC9FD1C3A}</a:tableStyleId>
              </a:tblPr>
              <a:tblGrid>
                <a:gridCol w="175515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0536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31071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00807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8377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186846"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zh-TW" sz="1200" i="1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hamaecyparis obtusa </a:t>
                      </a:r>
                      <a:r>
                        <a:rPr lang="zh-TW" sz="12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Sieb. et Zucc.) Endl.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 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7,7-dimethyl-2-methylenenorboane;3-Ramounidone;isoraminol; L-fenketone;2,7,7-trimethyl-2-nordicol;(R)-1-terpene-4-ol;α,α,4-trimethyl-benzylalcohol;(S)-1-terpene-8-alcohol;1,4-terpinediene-7-alcohol;2-bornone;2-bohol acetate;1-terpene-8-alcoholacetate; 1,2,2,3tetramethyl－3- cyclopentene-1-ol;4-isopropylbenzylalcohol;2,6-dimethyl-6-benoxy-2,7-octylodiene-1 alcohol; 1,2-epoxy-limonene;Epoxidized-β-caryophyllene;1,5,5,8-tetramethyl-12-oxadiocyclic [9∙1∙0] dodec-3,7-diene;3-dimethyl-5-formyl-6-vinyl-6-hydroxy-dicyclic[3∙2∙0]hept-2-ketone; 3- methyl - (8β, 13β) -17- </a:t>
                      </a:r>
                      <a:r>
                        <a:rPr lang="en-US" sz="1000" kern="0" dirty="0" err="1">
                          <a:effectLst/>
                        </a:rPr>
                        <a:t>norkauri</a:t>
                      </a:r>
                      <a:r>
                        <a:rPr lang="en-US" sz="1000" kern="0" dirty="0">
                          <a:effectLst/>
                        </a:rPr>
                        <a:t> -15- </a:t>
                      </a:r>
                      <a:r>
                        <a:rPr lang="en-US" sz="1000" kern="0" dirty="0" err="1">
                          <a:effectLst/>
                        </a:rPr>
                        <a:t>ene</a:t>
                      </a:r>
                      <a:r>
                        <a:rPr lang="en-US" sz="1000" kern="0" dirty="0">
                          <a:effectLst/>
                        </a:rPr>
                        <a:t>; </a:t>
                      </a:r>
                      <a:r>
                        <a:rPr lang="en-US" sz="1000" kern="0" dirty="0" err="1">
                          <a:effectLst/>
                        </a:rPr>
                        <a:t>prepalin</a:t>
                      </a:r>
                      <a:endParaRPr lang="en-US" sz="1000" kern="0" dirty="0">
                        <a:effectLst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1. Stop the bleeding (shorten the time of blood clotting). </a:t>
                      </a:r>
                    </a:p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2. Antibacterial (bacteriostatic) Diplococcus pneumoniae, Staphylococcus aureus, Staphylococcus albicans, Bacillus </a:t>
                      </a:r>
                      <a:r>
                        <a:rPr lang="en-US" sz="1000" kern="0" dirty="0" err="1">
                          <a:effectLst/>
                        </a:rPr>
                        <a:t>dysenteriae</a:t>
                      </a:r>
                      <a:r>
                        <a:rPr lang="en-US" sz="1000" kern="0" dirty="0">
                          <a:effectLst/>
                        </a:rPr>
                        <a:t> </a:t>
                      </a:r>
                      <a:r>
                        <a:rPr lang="en-US" sz="1000" kern="0" dirty="0" err="1">
                          <a:effectLst/>
                        </a:rPr>
                        <a:t>Sonnei</a:t>
                      </a:r>
                      <a:r>
                        <a:rPr lang="en-US" sz="1000" kern="0" dirty="0">
                          <a:effectLst/>
                        </a:rPr>
                        <a:t>. The alcohol extract inhibited Mycobacterium tuberculosis (concentration of 1:180,000). </a:t>
                      </a:r>
                    </a:p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3. relieve the blood in urine, vomiting, high blood pressure. </a:t>
                      </a:r>
                    </a:p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4. Antitussive effect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</a:rPr>
                        <a:t>26</a:t>
                      </a:r>
                      <a:endParaRPr lang="zh-TW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52537"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zh-TW" sz="1200" i="1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Juniperus chinensis </a:t>
                      </a:r>
                      <a:r>
                        <a:rPr lang="zh-TW" sz="12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'Pyramidali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TW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Phellandrene (13.713% of the total volatile oil), L- </a:t>
                      </a:r>
                      <a:r>
                        <a:rPr lang="en-US" sz="1000" kern="0" dirty="0" err="1">
                          <a:effectLst/>
                        </a:rPr>
                        <a:t>borneolacetate</a:t>
                      </a:r>
                      <a:r>
                        <a:rPr lang="en-US" sz="1000" kern="0" dirty="0">
                          <a:effectLst/>
                        </a:rPr>
                        <a:t> (10.490%), L-4-terpineol (10.163%), limonene (9.447%), </a:t>
                      </a:r>
                      <a:r>
                        <a:rPr lang="en-US" sz="1000" kern="0" dirty="0" err="1">
                          <a:effectLst/>
                        </a:rPr>
                        <a:t>terpinene</a:t>
                      </a:r>
                      <a:r>
                        <a:rPr lang="en-US" sz="1000" kern="0" dirty="0">
                          <a:effectLst/>
                        </a:rPr>
                        <a:t> (5.134%), π-pinene (4.397%), </a:t>
                      </a:r>
                      <a:r>
                        <a:rPr lang="en-US" sz="1000" kern="0" dirty="0" err="1">
                          <a:effectLst/>
                        </a:rPr>
                        <a:t>terpilene</a:t>
                      </a:r>
                      <a:r>
                        <a:rPr lang="en-US" sz="1000" kern="0" dirty="0">
                          <a:effectLst/>
                        </a:rPr>
                        <a:t> (3.424%),　terpinolene (2.776%), germacrene (2. 628% ) 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Volatile oil (special fragrance, incense, bacteriostatic agent, bioactive insecticide). antitumor and antibacterial effect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TW" sz="12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2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132114"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zh-TW" sz="1200" i="1" kern="100" dirty="0">
                          <a:effectLst/>
                        </a:rPr>
                        <a:t>Sabina chinensis</a:t>
                      </a:r>
                    </a:p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 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β-</a:t>
                      </a:r>
                      <a:r>
                        <a:rPr lang="en-US" sz="1000" kern="0" dirty="0" err="1">
                          <a:effectLst/>
                        </a:rPr>
                        <a:t>phellandrene</a:t>
                      </a:r>
                      <a:r>
                        <a:rPr lang="en-US" sz="1000" kern="0" dirty="0">
                          <a:effectLst/>
                        </a:rPr>
                        <a:t> (26.64-39.26%), terpinen-4-ol (6.53-11.89%), </a:t>
                      </a:r>
                      <a:r>
                        <a:rPr lang="en-US" sz="1000" kern="0" dirty="0" err="1">
                          <a:effectLst/>
                        </a:rPr>
                        <a:t>bornyl</a:t>
                      </a:r>
                      <a:r>
                        <a:rPr lang="en-US" sz="1000" kern="0" dirty="0">
                          <a:effectLst/>
                        </a:rPr>
                        <a:t> acetate (6.13-10.53%) of essential oil. Sabina </a:t>
                      </a:r>
                      <a:r>
                        <a:rPr lang="en-US" sz="1000" kern="0" dirty="0" err="1">
                          <a:effectLst/>
                        </a:rPr>
                        <a:t>chinensis</a:t>
                      </a:r>
                      <a:r>
                        <a:rPr lang="en-US" sz="1000" kern="0" dirty="0">
                          <a:effectLst/>
                        </a:rPr>
                        <a:t> contains Dragon brain acetate (46.5%) of volatile oil.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zh-TW" sz="12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nhibits fungal effects  Antifungal activity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22</a:t>
                      </a:r>
                      <a:r>
                        <a:rPr lang="zh-CN" altLang="en-US" sz="1000" kern="0" dirty="0">
                          <a:effectLst/>
                        </a:rPr>
                        <a:t>，</a:t>
                      </a:r>
                      <a:r>
                        <a:rPr lang="en-US" altLang="zh-CN" sz="1000" kern="0" dirty="0">
                          <a:effectLst/>
                        </a:rPr>
                        <a:t>34</a:t>
                      </a:r>
                      <a:endParaRPr lang="en-US" altLang="zh-CN" sz="1000" kern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132114"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zh-TW" sz="1200" i="1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Juniperus chinensi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branches and leaves </a:t>
                      </a:r>
                      <a:endParaRPr lang="zh-TW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The principle component of </a:t>
                      </a:r>
                      <a:r>
                        <a:rPr lang="en-US" sz="1000" kern="0" dirty="0" err="1">
                          <a:effectLst/>
                        </a:rPr>
                        <a:t>Juniperus</a:t>
                      </a:r>
                      <a:r>
                        <a:rPr lang="en-US" sz="1000" kern="0" dirty="0">
                          <a:effectLst/>
                        </a:rPr>
                        <a:t> </a:t>
                      </a:r>
                      <a:r>
                        <a:rPr lang="en-US" sz="1000" kern="0" dirty="0" err="1">
                          <a:effectLst/>
                        </a:rPr>
                        <a:t>Oxycedrus</a:t>
                      </a:r>
                      <a:r>
                        <a:rPr lang="en-US" sz="1000" kern="0" dirty="0">
                          <a:effectLst/>
                        </a:rPr>
                        <a:t> Tar is </a:t>
                      </a:r>
                      <a:r>
                        <a:rPr lang="en-US" sz="1000" kern="0" dirty="0" err="1">
                          <a:effectLst/>
                        </a:rPr>
                        <a:t>cadinene</a:t>
                      </a:r>
                      <a:r>
                        <a:rPr lang="en-US" sz="1000" kern="0" dirty="0">
                          <a:effectLst/>
                        </a:rPr>
                        <a:t>, cresol and </a:t>
                      </a:r>
                      <a:r>
                        <a:rPr lang="en-US" sz="1000" kern="0" dirty="0" err="1">
                          <a:effectLst/>
                        </a:rPr>
                        <a:t>guaiacol</a:t>
                      </a:r>
                      <a:r>
                        <a:rPr lang="en-US" sz="1000" kern="0" dirty="0">
                          <a:effectLst/>
                        </a:rPr>
                        <a:t>. </a:t>
                      </a:r>
                    </a:p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95% ethanol extract: Thing, </a:t>
                      </a:r>
                      <a:r>
                        <a:rPr lang="en-US" sz="1000" kern="0" dirty="0" err="1">
                          <a:effectLst/>
                        </a:rPr>
                        <a:t>Mogrohan</a:t>
                      </a:r>
                      <a:r>
                        <a:rPr lang="en-US" sz="1000" kern="0" dirty="0">
                          <a:effectLst/>
                        </a:rPr>
                        <a:t> pine resin (Ⅰ)、</a:t>
                      </a:r>
                      <a:r>
                        <a:rPr lang="en-US" sz="1000" kern="0" dirty="0" err="1">
                          <a:effectLst/>
                        </a:rPr>
                        <a:t>Hinolipids</a:t>
                      </a:r>
                      <a:r>
                        <a:rPr lang="en-US" sz="1000" kern="0" dirty="0">
                          <a:effectLst/>
                        </a:rPr>
                        <a:t> (Ⅱ)、Quercetin (Ⅲ)、</a:t>
                      </a:r>
                      <a:r>
                        <a:rPr lang="en-US" sz="1000" kern="0" dirty="0" err="1">
                          <a:effectLst/>
                        </a:rPr>
                        <a:t>Robinitin</a:t>
                      </a:r>
                      <a:r>
                        <a:rPr lang="en-US" sz="1000" kern="0" dirty="0">
                          <a:effectLst/>
                        </a:rPr>
                        <a:t> (Ⅳ)、Quercetin 3-O-α-L-</a:t>
                      </a:r>
                      <a:r>
                        <a:rPr lang="en-US" sz="1000" kern="0" dirty="0" err="1">
                          <a:effectLst/>
                        </a:rPr>
                        <a:t>rhamnoside</a:t>
                      </a:r>
                      <a:r>
                        <a:rPr lang="en-US" sz="1000" kern="0" dirty="0">
                          <a:effectLst/>
                        </a:rPr>
                        <a:t> (Ⅴ)、</a:t>
                      </a:r>
                      <a:r>
                        <a:rPr lang="en-US" sz="1000" kern="0" dirty="0" err="1">
                          <a:effectLst/>
                        </a:rPr>
                        <a:t>Kaempferol</a:t>
                      </a:r>
                      <a:r>
                        <a:rPr lang="en-US" sz="1000" kern="0" dirty="0">
                          <a:effectLst/>
                        </a:rPr>
                        <a:t> 3-O-α-L-</a:t>
                      </a:r>
                      <a:r>
                        <a:rPr lang="en-US" sz="1000" kern="0" dirty="0" err="1">
                          <a:effectLst/>
                        </a:rPr>
                        <a:t>rhamnoside</a:t>
                      </a:r>
                      <a:r>
                        <a:rPr lang="en-US" sz="1000" kern="0" dirty="0">
                          <a:effectLst/>
                        </a:rPr>
                        <a:t> (Ⅵ)、Spike shirt flavonoids (Ⅶ) </a:t>
                      </a:r>
                      <a:r>
                        <a:rPr lang="en-US" sz="1000" kern="0" dirty="0" err="1">
                          <a:effectLst/>
                        </a:rPr>
                        <a:t>Mogrohan</a:t>
                      </a:r>
                      <a:r>
                        <a:rPr lang="en-US" sz="1000" kern="0" dirty="0">
                          <a:effectLst/>
                        </a:rPr>
                        <a:t> pine </a:t>
                      </a:r>
                      <a:r>
                        <a:rPr lang="en-US" sz="1000" kern="0" dirty="0" err="1">
                          <a:effectLst/>
                        </a:rPr>
                        <a:t>diflavone</a:t>
                      </a:r>
                      <a:r>
                        <a:rPr lang="en-US" sz="1000" kern="0" dirty="0">
                          <a:effectLst/>
                        </a:rPr>
                        <a:t> A (Ⅷ) and β- </a:t>
                      </a:r>
                      <a:r>
                        <a:rPr lang="en-US" sz="1000" kern="0" dirty="0" err="1">
                          <a:effectLst/>
                        </a:rPr>
                        <a:t>sitosterol</a:t>
                      </a:r>
                      <a:r>
                        <a:rPr lang="en-US" sz="1000" kern="0" dirty="0">
                          <a:effectLst/>
                        </a:rPr>
                        <a:t>(Ⅸ)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Volatile oil inhibited lung cancer cells NCI-H460.</a:t>
                      </a:r>
                    </a:p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effectLst/>
                        </a:rPr>
                        <a:t>An inhibitory effect on kidney disease or urinary disorders, gynecological diseases, pestilence and external medicinal baths used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127000"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TW" sz="12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3-25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D980ADD1-E1E1-4680-8E13-E5D62344DA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28613"/>
            <a:ext cx="10515600" cy="5848350"/>
          </a:xfrm>
        </p:spPr>
        <p:txBody>
          <a:bodyPr>
            <a:noAutofit/>
          </a:bodyPr>
          <a:lstStyle/>
          <a:p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6.Huyan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a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.L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Zha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.Y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u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.X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ahid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.R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a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.Q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-tumor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ffect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ot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queou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tract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onchus oleraceus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L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. and 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uniperus sabina L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—Two traditional medicinal plants in China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. Ethnopharmacol. </a:t>
            </a:r>
            <a:r>
              <a:rPr lang="en-US" sz="800" b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016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85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289–299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2"/>
              </a:rPr>
              <a:t>https://doi.org/10.1016/j.jep.2016.03.044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US" sz="800" kern="10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7.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bdel-Kader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.S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liman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.A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qarni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.H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amad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.M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udah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.I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qasoumi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.I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emica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position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tective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ffect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uniperus sabina,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ssentia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i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ainst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l4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uced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patotoxicity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audi Pharm. J. </a:t>
            </a:r>
            <a:r>
              <a:rPr lang="en-US" sz="800" b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019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7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945–951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tps://doi.org/10.1016/j.jsps.2019.07.003.</a:t>
            </a:r>
            <a:endParaRPr lang="en-US" sz="8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sz="8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8.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Xu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X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u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ian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uniperus sabina,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urce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dophyllotoxins: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traction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ptimization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cholinesterase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tivities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t. J. Mol. Sci. </a:t>
            </a:r>
            <a:r>
              <a:rPr lang="en-US" sz="800" b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022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3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0205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tps://doi.org/10.3390/ijms231810205.</a:t>
            </a:r>
            <a:endParaRPr lang="en-US" sz="8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sz="8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9.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rhan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liorman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han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ökbulut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lan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rgun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parative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emica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file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oxidant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-vitro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-vivo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diabetic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tivitie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uniperus foetidissima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lld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uniperus sabina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Iran. J. Pharm. Res.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017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6, 64–74.</a:t>
            </a:r>
            <a:endParaRPr lang="en-US" sz="8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sz="8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0.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hi, R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SimSun" panose="02010600030101010101" pitchFamily="2" charset="-122"/>
              </a:rPr>
              <a:t>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, J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chanism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abina przewalskii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ronic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bstructive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ulmonary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ease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sed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etwork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armacology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. Qinghai Norm. Univ. </a:t>
            </a:r>
            <a:r>
              <a:rPr lang="en-US" sz="800" b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022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38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4–52.</a:t>
            </a:r>
            <a:endParaRPr lang="en-US" sz="8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sz="8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1.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ark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.A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egal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u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.W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u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.J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h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.G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u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.Y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hn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im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a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.H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solation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yrosinase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lanogenesi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hibitory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lavonoid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uniperus chinensis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uits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iosci. Biotechnol. Biochem. </a:t>
            </a:r>
            <a:r>
              <a:rPr lang="en-US" sz="800" b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018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82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041–2048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tps://doi.org/10.1080/09168451.2018.1511367.</a:t>
            </a:r>
            <a:endParaRPr lang="en-US" sz="8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sz="8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2.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ui, Y.; Nan, P.; Lin, M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in Volatile Components in the Leaves of 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bina chinensis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. Ant. and 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bina chinensis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. Ant. Cv. Kaizuca and Their Effects on Bacteria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J. Environ. Health </a:t>
            </a:r>
            <a:r>
              <a:rPr lang="en-US" sz="800" b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006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63–65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https://doi.org/10.16241/j.cnki.1001-5914.2006.01.028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US" sz="800" kern="10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3.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ersen, F.A. Fina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ort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fety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sessment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uniperus communis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tract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uniperus oxycedrus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tract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uniperus oxycedrus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r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uniperus phoenicea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tract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uniperus virginiana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tract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t. J. Toxicol. </a:t>
            </a:r>
            <a:r>
              <a:rPr lang="en-US" sz="800" b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001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0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Suppl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2)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1–56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tps://doi.org/10.1080/10915810160233758.</a:t>
            </a:r>
            <a:endParaRPr lang="en-US" sz="8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sz="8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4.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i, R.L.; Wu, P.L.; Li, C.R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emica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stituent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ranche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eave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uniperus formosana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st China J. Pharm. </a:t>
            </a:r>
            <a:r>
              <a:rPr lang="en-US" sz="800" b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019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34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–9.</a:t>
            </a:r>
            <a:endParaRPr lang="en-US" sz="8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sz="8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5.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Wu, S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Lin, Y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dvance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in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inese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Juniper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leaves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Chin. J. Ethn. Med. </a:t>
            </a:r>
            <a:r>
              <a:rPr lang="en-US" sz="800" b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2014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20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55–58.</a:t>
            </a:r>
            <a:endParaRPr lang="en-US" sz="8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sz="8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6.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iang, J.H.; Li, X.C.; Gao, T.H.; He, D.N.; Chen, F.M.; Zhang, Y.P.; Huang, L.B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Volatile Constituents from the Cupressaceae Plants and Their Antitumor Activities. 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J. 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ujian For. Sci. Technol. </a:t>
            </a:r>
            <a:r>
              <a:rPr lang="en-US" sz="800" b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2006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2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52–57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ttps://doi.org/10.13428/j.cnki.fjlk.2006.02.013.</a:t>
            </a:r>
            <a:endParaRPr lang="en-US" sz="8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sz="8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7.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u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X.D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X.Y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.B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o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X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.D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.Y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Zhao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.S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terpenoid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wig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eave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kienia hodginsii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. Nat. Prod. </a:t>
            </a:r>
            <a:r>
              <a:rPr lang="en-US" sz="800" b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013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76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1032–1038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tps://doi.org/10.1021/np400010c.</a:t>
            </a:r>
            <a:endParaRPr lang="en-US" sz="8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sz="8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8.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u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X.D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Zho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.W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.F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u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.C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a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o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X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.Y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Xu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Z.Z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Zhao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.S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squiterpenoid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wig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eave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kienia hodginsii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. Asian Nat. Prod. Res. </a:t>
            </a:r>
            <a:r>
              <a:rPr lang="en-US" sz="800" b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017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9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666–672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tps://doi.org/10.1080/10286020.2016.1247350.</a:t>
            </a:r>
            <a:endParaRPr lang="en-US" sz="8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sz="8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30.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Zhang, Y.; Yang, S.; Cao, Q.; Zhang, W.; Chen, F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tudy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on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he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emica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onstituent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nd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Biologica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ctivitie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Volatile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Oi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rom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Fokienia hodgisii. Anhui Agric. Sci. </a:t>
            </a:r>
            <a:r>
              <a:rPr lang="en-US" sz="800" b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2008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17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7290–7291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7298.</a:t>
            </a:r>
            <a:endParaRPr lang="en-US" sz="8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sz="8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32.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Liu, Y.X.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nalysi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hemica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onstituent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Essentia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Oi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Extracted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rom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Leave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nd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eeds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Sabina chinensis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J. Hubei Univ. Natl. </a:t>
            </a:r>
            <a:r>
              <a:rPr lang="en-US" sz="800" b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2013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31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414–418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441.</a:t>
            </a:r>
            <a:endParaRPr lang="en-US" sz="8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sz="8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33.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u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a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u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a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emica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position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-amylase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hibitory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tivity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ssentia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i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abina chinensis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v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Kaizuca leaves. Nat. Prod. Res. </a:t>
            </a:r>
            <a:r>
              <a:rPr lang="en-US" sz="800" b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018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32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711–713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4"/>
              </a:rPr>
              <a:t>https://doi.org/10.1080/14786419.2017.1332612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US" sz="800" kern="10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34.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Zha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Zhao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Z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a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Zhe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u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X.;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ng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ssentia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i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abina chinensis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eaves: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mising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een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ent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ainst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usarium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p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ront. Plant Sci. </a:t>
            </a:r>
            <a:r>
              <a:rPr lang="en-US" sz="800" b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022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3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006303.</a:t>
            </a:r>
            <a:r>
              <a:rPr lang="en-US" sz="800" i="1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tps://doi.org/10.3389/fpls.2022.1006303.</a:t>
            </a:r>
            <a:endParaRPr lang="en-US" sz="8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sz="80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75.</a:t>
            </a:r>
            <a:r>
              <a:rPr lang="en-US" sz="800"/>
              <a:t> Zhao, J.; Gu, Z.; Liu, T.; Xu, F.; You, S.; Li, C. Anti-arthritic effects of total flavonoids from Juniperus sabina on complete freund's adjuvant induced arthritis in rats. </a:t>
            </a:r>
            <a:r>
              <a:rPr lang="en-US" sz="800" i="1"/>
              <a:t>Pharmacogn. Mag.</a:t>
            </a:r>
            <a:r>
              <a:rPr lang="en-US" sz="800"/>
              <a:t> </a:t>
            </a:r>
            <a:r>
              <a:rPr lang="en-US" sz="800" b="1"/>
              <a:t>2016</a:t>
            </a:r>
            <a:r>
              <a:rPr lang="en-US" sz="800"/>
              <a:t>, </a:t>
            </a:r>
            <a:r>
              <a:rPr lang="en-US" sz="800" i="1"/>
              <a:t>12</a:t>
            </a:r>
            <a:r>
              <a:rPr lang="en-US" sz="800"/>
              <a:t>, 178–83, https://doi.org/10.4103/0973-1296.186346. </a:t>
            </a:r>
          </a:p>
          <a:p>
            <a:endParaRPr lang="en-US" sz="8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endParaRPr lang="en-US" sz="8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endParaRPr lang="en-US" sz="80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endParaRPr lang="en-US" sz="800"/>
          </a:p>
        </p:txBody>
      </p:sp>
    </p:spTree>
    <p:extLst>
      <p:ext uri="{BB962C8B-B14F-4D97-AF65-F5344CB8AC3E}">
        <p14:creationId xmlns:p14="http://schemas.microsoft.com/office/powerpoint/2010/main" val="4145285407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M2RjYzg2NWQ2ZDIxNmIyZDNjMDI3ODg5NTYzMjJkMWUifQ=="/>
</p:tagLst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2165</Words>
  <Application>Microsoft Office PowerPoint</Application>
  <PresentationFormat>Widescreen</PresentationFormat>
  <Paragraphs>111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Palatino Linotype</vt:lpstr>
      <vt:lpstr>Times New Roman</vt:lpstr>
      <vt:lpstr>Office 佈景主題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Renata Carla Chelariu</cp:lastModifiedBy>
  <cp:revision>13</cp:revision>
  <dcterms:created xsi:type="dcterms:W3CDTF">2024-07-24T15:22:00Z</dcterms:created>
  <dcterms:modified xsi:type="dcterms:W3CDTF">2024-07-28T19:01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2986F151CC8648898030441D91880515_13</vt:lpwstr>
  </property>
  <property fmtid="{D5CDD505-2E9C-101B-9397-08002B2CF9AE}" pid="3" name="KSOProductBuildVer">
    <vt:lpwstr>2052-12.1.0.17147</vt:lpwstr>
  </property>
</Properties>
</file>